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316" r:id="rId2"/>
    <p:sldId id="317" r:id="rId3"/>
    <p:sldId id="314" r:id="rId4"/>
    <p:sldId id="310" r:id="rId5"/>
    <p:sldId id="321" r:id="rId6"/>
    <p:sldId id="322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228" userDrawn="1">
          <p15:clr>
            <a:srgbClr val="A4A3A4"/>
          </p15:clr>
        </p15:guide>
        <p15:guide id="3" orient="horz" pos="25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99"/>
    <a:srgbClr val="14A1A1"/>
    <a:srgbClr val="5252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9474" autoAdjust="0"/>
  </p:normalViewPr>
  <p:slideViewPr>
    <p:cSldViewPr snapToGrid="0" showGuides="1">
      <p:cViewPr varScale="1">
        <p:scale>
          <a:sx n="57" d="100"/>
          <a:sy n="57" d="100"/>
        </p:scale>
        <p:origin x="662" y="48"/>
      </p:cViewPr>
      <p:guideLst>
        <p:guide pos="3228"/>
        <p:guide orient="horz" pos="254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747C1F-C5F0-4D51-AE20-9D6E000CB76D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576683-A361-45CB-AD9A-07D3FEC5A4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579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906A3-CB52-4A1C-8963-3F020087AF77}" type="datetimeFigureOut">
              <a:rPr lang="ko-KR" altLang="en-US" smtClean="0"/>
              <a:t>2026-0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24351-C580-4D03-913F-E5C45606102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13" Type="http://schemas.openxmlformats.org/officeDocument/2006/relationships/image" Target="../media/image17.tiff"/><Relationship Id="rId3" Type="http://schemas.openxmlformats.org/officeDocument/2006/relationships/image" Target="../media/image7.jpeg"/><Relationship Id="rId7" Type="http://schemas.openxmlformats.org/officeDocument/2006/relationships/image" Target="../media/image11.tiff"/><Relationship Id="rId12" Type="http://schemas.openxmlformats.org/officeDocument/2006/relationships/image" Target="../media/image16.tiff"/><Relationship Id="rId17" Type="http://schemas.openxmlformats.org/officeDocument/2006/relationships/image" Target="../media/image21.tiff"/><Relationship Id="rId2" Type="http://schemas.openxmlformats.org/officeDocument/2006/relationships/image" Target="../media/image6.tiff"/><Relationship Id="rId16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11" Type="http://schemas.openxmlformats.org/officeDocument/2006/relationships/image" Target="../media/image15.tiff"/><Relationship Id="rId5" Type="http://schemas.openxmlformats.org/officeDocument/2006/relationships/image" Target="../media/image9.tiff"/><Relationship Id="rId15" Type="http://schemas.openxmlformats.org/officeDocument/2006/relationships/image" Target="../media/image19.tiff"/><Relationship Id="rId10" Type="http://schemas.openxmlformats.org/officeDocument/2006/relationships/image" Target="../media/image14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Relationship Id="rId14" Type="http://schemas.openxmlformats.org/officeDocument/2006/relationships/image" Target="../media/image1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551742" y="659480"/>
            <a:ext cx="7392995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square">
            <a:spAutoFit/>
          </a:bodyPr>
          <a:lstStyle/>
          <a:p>
            <a:pPr eaLnBrk="0" hangingPunct="0"/>
            <a:r>
              <a:rPr lang="zh-CN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able 1 Primer sequences used in quantitative real-time PCR</a:t>
            </a:r>
            <a:endParaRPr lang="zh-CN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5735" y="102869"/>
            <a:ext cx="2928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417658" y="1215033"/>
            <a:ext cx="49885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hangingPunct="0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at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439792" y="1585423"/>
          <a:ext cx="5670550" cy="438912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88976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91020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7058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-RA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CCATCGGCAGACCAAT</a:t>
                      </a:r>
                      <a:endParaRPr lang="zh-CN" sz="1200" b="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b="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0190"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-RA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CCAGCTCATCTGCACC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GF-RA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GGGAACAACTCAACAG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GF-RA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CCACTACAGCGACTCAG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-1α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TCTGAAAGGGCCAAG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019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-1α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AATCACACGGCGCTCT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F1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GCAGCACCTTTGGAGAATGTG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F1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GATGGTGAGAGGGGGCAGTT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AM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CTAAAGAAGAAAGCAC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AM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CAACTTCAGCCATT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RNA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GGTTCTATTTTGTTGG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RNA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CGGCATCGTTTATGGT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6377637" y="1215033"/>
            <a:ext cx="10486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latinLnBrk="0" hangingPunct="0"/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wo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ell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表格 6"/>
          <p:cNvGraphicFramePr>
            <a:graphicFrameLocks noGrp="1"/>
          </p:cNvGraphicFramePr>
          <p:nvPr/>
        </p:nvGraphicFramePr>
        <p:xfrm>
          <a:off x="6377637" y="1600000"/>
          <a:ext cx="5670550" cy="292608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88976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91020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7058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 i13 (V2)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n-US" sz="1200" b="0" kern="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GGAGGGGAGGATGTTAG</a:t>
                      </a:r>
                      <a:endParaRPr lang="zh-CN" sz="1200" b="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b="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0190"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 i13 (V2)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n-US" sz="1200" kern="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GGGAGGTGCGTTGAAC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 e15 α  (V3)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GCCTCAGATCACTTGGTT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 e15 α  (V3)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TTGGCTCTCCAACTAAAGG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-1α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CACTACAGACACCG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019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-1α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TAGCTGTCATACCTGGG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RNA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GAGGGAGCCTGAGAAAC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RNA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CCAATGGATCCTCGTT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122762" y="261010"/>
            <a:ext cx="6096000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>
            <a:spAutoFit/>
          </a:bodyPr>
          <a:lstStyle/>
          <a:p>
            <a:pPr eaLnBrk="0" hangingPunct="0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able 2 Primary antibodies used in western blotting</a:t>
            </a:r>
            <a:endParaRPr lang="zh-CN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3270681" y="758828"/>
          <a:ext cx="5650684" cy="603504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412671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41267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412671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412671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target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ue number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entration used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PHOS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1041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 μ g/ml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NK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us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100-494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IP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8699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IP3L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114914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DC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77785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P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70S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S 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2214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A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42364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N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3804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N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2477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susa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-4246R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 A/C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69532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neurin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282104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lt-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32152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eratin-7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81598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55961"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47778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tc>
                  <a:txBody>
                    <a:bodyPr/>
                    <a:lstStyle/>
                    <a:p>
                      <a:pPr algn="just" eaLnBrk="0" latinLnBrk="0" hangingPunct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7591" marR="57591" marT="0" marB="0"/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94310" y="102870"/>
            <a:ext cx="2928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865629" y="965879"/>
          <a:ext cx="5089898" cy="27394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272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09787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8536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7132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6261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566779"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m</a:t>
                      </a:r>
                      <a:endParaRPr lang="zh-CN" sz="1050" b="1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are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remaining are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rea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/total area(%)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19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1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9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14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4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50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49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76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0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63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3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76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5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9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4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5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18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9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1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8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81054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1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</a:t>
                      </a: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870117" y="3856376"/>
          <a:ext cx="5117215" cy="27683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3443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02344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2344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23443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2344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549095"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</a:t>
                      </a: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area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remaining area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rea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/total area(%)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5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15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73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19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4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6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86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14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000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%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66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88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54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95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0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97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45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76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65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4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3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93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26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0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29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59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8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21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8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939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84938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45</a:t>
                      </a:r>
                      <a:endParaRPr lang="zh-CN" sz="11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91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836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  <a:endParaRPr lang="zh-CN" sz="11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6142492" y="970061"/>
          <a:ext cx="5227873" cy="27590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187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9414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9929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8647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4608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559592"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m+MT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are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remaining are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rea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/total area(%)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111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42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6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69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3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18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42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56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2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1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6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4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2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8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6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4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6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0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60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6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2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26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81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83292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73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21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6158767" y="3861811"/>
          <a:ext cx="5249546" cy="27279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0773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7869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9140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7789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10078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181610"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100" kern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</a:t>
                      </a: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kern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+MT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area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remaining area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re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 hangingPunct="0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 layer /total area(%)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1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79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2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2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97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04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571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37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920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15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1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629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%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3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415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08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3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01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5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79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6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09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70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62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69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4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948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094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06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799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005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 hangingPunct="0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94310" y="102870"/>
            <a:ext cx="3178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850790" y="575565"/>
            <a:ext cx="10535478" cy="28317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able 1              Quantitativ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ata of the basal decidua are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4310" y="102870"/>
            <a:ext cx="325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직사각형 79"/>
          <p:cNvSpPr/>
          <p:nvPr/>
        </p:nvSpPr>
        <p:spPr>
          <a:xfrm>
            <a:off x="13193135" y="916396"/>
            <a:ext cx="5056821" cy="489364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marL="228600" indent="-228600" eaLnBrk="0" fontAlgn="t" latinLnBrk="0" hangingPunct="0">
              <a:lnSpc>
                <a:spcPct val="200000"/>
              </a:lnSpc>
              <a:buAutoNum type="alphaUcPeriod"/>
            </a:pP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lt-1 i13 mRNA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Sham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+MT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+MT four 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s in </a:t>
            </a:r>
            <a:r>
              <a:rPr lang="en-US" altLang="ko-KR" sz="1200" kern="1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wo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</a:p>
          <a:p>
            <a:pPr marL="228600" indent="-228600" eaLnBrk="0" fontAlgn="t" latinLnBrk="0" hangingPunct="0">
              <a:lnSpc>
                <a:spcPct val="200000"/>
              </a:lnSpc>
              <a:buFontTx/>
              <a:buAutoNum type="alphaUcPeriod"/>
            </a:pP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Flt-1 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15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RNA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Sham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+MT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+MT four groups in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wo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lt-1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13 and sFlt-1 e15a are two subtypes of sFlt-1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228600" indent="-228600" eaLnBrk="0" fontAlgn="t" latinLnBrk="0" hangingPunct="0">
              <a:lnSpc>
                <a:spcPct val="200000"/>
              </a:lnSpc>
              <a:buFontTx/>
              <a:buAutoNum type="alphaUcPeriod"/>
            </a:pP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S 1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 expression 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Sham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+MT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+MT four groups in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wo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 is consistent with the findings from the previous placental tissue samples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228600" indent="-228600" eaLnBrk="0" fontAlgn="t" latinLnBrk="0" hangingPunct="0">
              <a:lnSpc>
                <a:spcPct val="200000"/>
              </a:lnSpc>
              <a:buFontTx/>
              <a:buAutoNum type="alphaUcPeriod"/>
            </a:pP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NIP3L protein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Sham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+MT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+MT four groups in </a:t>
            </a:r>
            <a:r>
              <a:rPr lang="en-US" altLang="ko-KR" sz="12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wo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. 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 result is consistent with the findings from the previous placental tissue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s.</a:t>
            </a:r>
            <a:endParaRPr lang="en-US" altLang="zh-CN" sz="1200" kern="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t" latinLnBrk="0" hangingPunct="0">
              <a:lnSpc>
                <a:spcPct val="200000"/>
              </a:lnSpc>
            </a:pPr>
            <a:r>
              <a:rPr lang="en-US" altLang="ko-KR" sz="12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 </a:t>
            </a:r>
            <a:r>
              <a:rPr lang="en-US" altLang="ko-KR" sz="12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 expressed as mean ± standard deviation range. *P&lt;0.05, **P&lt;0.005, ****P&lt;0.0001</a:t>
            </a:r>
            <a:endParaRPr lang="ko-KR" altLang="ko-KR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665200" y="260597"/>
            <a:ext cx="474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00B0F0"/>
                </a:solidFill>
              </a:rPr>
              <a:t>This should be in figure legends</a:t>
            </a:r>
            <a:endParaRPr lang="ko-KR" altLang="en-US" dirty="0">
              <a:solidFill>
                <a:srgbClr val="00B0F0"/>
              </a:solidFill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2453094" y="748191"/>
            <a:ext cx="8138706" cy="5882384"/>
            <a:chOff x="903694" y="775658"/>
            <a:chExt cx="7717864" cy="5578928"/>
          </a:xfrm>
        </p:grpSpPr>
        <p:sp>
          <p:nvSpPr>
            <p:cNvPr id="16" name="TextBox 15"/>
            <p:cNvSpPr txBox="1"/>
            <p:nvPr/>
          </p:nvSpPr>
          <p:spPr>
            <a:xfrm>
              <a:off x="971039" y="789518"/>
              <a:ext cx="408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그룹 16"/>
            <p:cNvGrpSpPr/>
            <p:nvPr/>
          </p:nvGrpSpPr>
          <p:grpSpPr>
            <a:xfrm>
              <a:off x="1257300" y="1117838"/>
              <a:ext cx="2652495" cy="2477341"/>
              <a:chOff x="4619" y="4312894"/>
              <a:chExt cx="2652495" cy="2477341"/>
            </a:xfrm>
          </p:grpSpPr>
          <p:sp>
            <p:nvSpPr>
              <p:cNvPr id="18" name="직사각형 17"/>
              <p:cNvSpPr/>
              <p:nvPr/>
            </p:nvSpPr>
            <p:spPr>
              <a:xfrm>
                <a:off x="934503" y="4774808"/>
                <a:ext cx="410185" cy="1187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9" name="직사각형 18"/>
              <p:cNvSpPr/>
              <p:nvPr/>
            </p:nvSpPr>
            <p:spPr>
              <a:xfrm>
                <a:off x="1446969" y="4725487"/>
                <a:ext cx="410185" cy="1187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0" name="TextBox 4"/>
              <p:cNvSpPr txBox="1"/>
              <p:nvPr/>
            </p:nvSpPr>
            <p:spPr>
              <a:xfrm>
                <a:off x="286789" y="4312894"/>
                <a:ext cx="22057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sFLT-1  </a:t>
                </a:r>
                <a:r>
                  <a:rPr lang="en-US" altLang="ko-KR" sz="1200" b="1" kern="0" noProof="0" dirty="0">
                    <a:solidFill>
                      <a:prstClr val="black"/>
                    </a:solidFill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i13 </a:t>
                </a: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mRNA</a:t>
                </a:r>
                <a:endParaRPr kumimoji="0" lang="en-US" altLang="ko-KR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1" name="개체 20"/>
              <p:cNvGraphicFramePr/>
              <p:nvPr/>
            </p:nvGraphicFramePr>
            <p:xfrm>
              <a:off x="334601" y="4631235"/>
              <a:ext cx="2322513" cy="2159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3472" name="Prism 8" r:id="rId3" imgW="2790825" imgH="2762250" progId="Prism8.Document">
                      <p:embed/>
                    </p:oleObj>
                  </mc:Choice>
                  <mc:Fallback>
                    <p:oleObj name="Prism 8" r:id="rId3" imgW="2790825" imgH="2762250" progId="Prism8.Document">
                      <p:embed/>
                      <p:pic>
                        <p:nvPicPr>
                          <p:cNvPr id="0" name="개체 81"/>
                          <p:cNvPicPr preferRelativeResize="0"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34601" y="4631235"/>
                            <a:ext cx="2322513" cy="2159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2" name="직사각형 9"/>
              <p:cNvSpPr/>
              <p:nvPr/>
            </p:nvSpPr>
            <p:spPr>
              <a:xfrm rot="16200000">
                <a:off x="-505296" y="5413502"/>
                <a:ext cx="1481495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latinLnBrk="0">
                  <a:defRPr/>
                </a:pPr>
                <a:r>
                  <a:rPr lang="en-US" altLang="ko-KR" sz="12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NA Expression </a:t>
                </a:r>
              </a:p>
              <a:p>
                <a:pPr algn="ctr" latinLnBrk="0">
                  <a:defRPr/>
                </a:pPr>
                <a:r>
                  <a:rPr lang="en-US" altLang="zh-CN" sz="12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sFlt-1(i13)</a:t>
                </a:r>
                <a:r>
                  <a:rPr lang="zh-CN" altLang="en-US" sz="12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endParaRPr lang="en-US" altLang="ko-KR" sz="12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직사각형 22"/>
              <p:cNvSpPr/>
              <p:nvPr/>
            </p:nvSpPr>
            <p:spPr>
              <a:xfrm>
                <a:off x="974695" y="4784849"/>
                <a:ext cx="410185" cy="1187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4" name="직사각형 23"/>
              <p:cNvSpPr/>
              <p:nvPr/>
            </p:nvSpPr>
            <p:spPr>
              <a:xfrm>
                <a:off x="1487161" y="4735528"/>
                <a:ext cx="410185" cy="1187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53884" y="4634066"/>
                <a:ext cx="335951" cy="2261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ko-KR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510538" y="4634066"/>
                <a:ext cx="308219" cy="2638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####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직사각형 26"/>
              <p:cNvSpPr/>
              <p:nvPr/>
            </p:nvSpPr>
            <p:spPr>
              <a:xfrm>
                <a:off x="445761" y="4766001"/>
                <a:ext cx="258815" cy="177582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66232" y="512545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94473" y="6194488"/>
                <a:ext cx="2696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66232" y="584938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66232" y="548278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66232" y="475661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그룹 32"/>
            <p:cNvGrpSpPr/>
            <p:nvPr/>
          </p:nvGrpSpPr>
          <p:grpSpPr>
            <a:xfrm>
              <a:off x="3975118" y="1068644"/>
              <a:ext cx="2606845" cy="2481606"/>
              <a:chOff x="2287418" y="4312894"/>
              <a:chExt cx="2606845" cy="2481606"/>
            </a:xfrm>
          </p:grpSpPr>
          <p:graphicFrame>
            <p:nvGraphicFramePr>
              <p:cNvPr id="34" name="개체 33"/>
              <p:cNvGraphicFramePr/>
              <p:nvPr/>
            </p:nvGraphicFramePr>
            <p:xfrm>
              <a:off x="2571750" y="4627563"/>
              <a:ext cx="2322513" cy="21669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3473" name="Prism 8" r:id="rId5" imgW="2790825" imgH="2809875" progId="Prism8.Document">
                      <p:embed/>
                    </p:oleObj>
                  </mc:Choice>
                  <mc:Fallback>
                    <p:oleObj name="Prism 8" r:id="rId5" imgW="2790825" imgH="2809875" progId="Prism8.Document">
                      <p:embed/>
                      <p:pic>
                        <p:nvPicPr>
                          <p:cNvPr id="0" name="개체 121"/>
                          <p:cNvPicPr preferRelativeResize="0"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571750" y="4627563"/>
                            <a:ext cx="2322513" cy="2166937"/>
                          </a:xfrm>
                          <a:prstGeom prst="rect">
                            <a:avLst/>
                          </a:prstGeom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5" name="직사각형 34"/>
              <p:cNvSpPr/>
              <p:nvPr/>
            </p:nvSpPr>
            <p:spPr>
              <a:xfrm>
                <a:off x="2787435" y="4737881"/>
                <a:ext cx="168970" cy="16875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620370" y="513289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748611" y="6201928"/>
                <a:ext cx="2696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620370" y="585682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620370" y="549022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620370" y="476405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.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직사각형 9"/>
              <p:cNvSpPr/>
              <p:nvPr/>
            </p:nvSpPr>
            <p:spPr>
              <a:xfrm rot="16200000">
                <a:off x="1777503" y="5383522"/>
                <a:ext cx="1481495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latinLnBrk="0">
                  <a:defRPr/>
                </a:pPr>
                <a:r>
                  <a:rPr lang="en-US" altLang="ko-KR" sz="12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NA Expression </a:t>
                </a:r>
              </a:p>
              <a:p>
                <a:pPr algn="ctr" latinLnBrk="0">
                  <a:defRPr/>
                </a:pPr>
                <a:r>
                  <a:rPr lang="en-US" altLang="zh-CN" sz="12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sFlt-1(e15a)</a:t>
                </a:r>
                <a:r>
                  <a:rPr lang="zh-CN" alt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endParaRPr lang="en-US" altLang="ko-KR" sz="12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직사각형 41"/>
              <p:cNvSpPr/>
              <p:nvPr/>
            </p:nvSpPr>
            <p:spPr>
              <a:xfrm>
                <a:off x="3216552" y="4678511"/>
                <a:ext cx="288648" cy="19509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3" name="직사각형 42"/>
              <p:cNvSpPr/>
              <p:nvPr/>
            </p:nvSpPr>
            <p:spPr>
              <a:xfrm>
                <a:off x="3789831" y="4697443"/>
                <a:ext cx="369308" cy="1507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190130" y="4565909"/>
                <a:ext cx="254335" cy="4362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ko-KR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ko-KR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720210" y="4553547"/>
                <a:ext cx="241105" cy="249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###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"/>
              <p:cNvSpPr txBox="1"/>
              <p:nvPr/>
            </p:nvSpPr>
            <p:spPr>
              <a:xfrm>
                <a:off x="2566298" y="4312894"/>
                <a:ext cx="22057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sFLT-1  </a:t>
                </a:r>
                <a:r>
                  <a:rPr lang="en-US" altLang="ko-KR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e15a</a:t>
                </a:r>
                <a:r>
                  <a:rPr lang="en-US" altLang="ko-KR" sz="1200" b="1" kern="0" noProof="0" dirty="0">
                    <a:solidFill>
                      <a:prstClr val="black"/>
                    </a:solidFill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 </a:t>
                </a: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mRNA</a:t>
                </a:r>
                <a:endParaRPr kumimoji="0" lang="en-US" altLang="ko-KR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7" name="TextBox 46"/>
            <p:cNvSpPr txBox="1"/>
            <p:nvPr/>
          </p:nvSpPr>
          <p:spPr>
            <a:xfrm>
              <a:off x="3935914" y="775658"/>
              <a:ext cx="408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그룹 50"/>
            <p:cNvGrpSpPr/>
            <p:nvPr/>
          </p:nvGrpSpPr>
          <p:grpSpPr>
            <a:xfrm>
              <a:off x="3761427" y="3863748"/>
              <a:ext cx="2724657" cy="2467378"/>
              <a:chOff x="8871657" y="4312894"/>
              <a:chExt cx="2724657" cy="2467378"/>
            </a:xfrm>
          </p:grpSpPr>
          <p:graphicFrame>
            <p:nvGraphicFramePr>
              <p:cNvPr id="52" name="개체 51"/>
              <p:cNvGraphicFramePr/>
              <p:nvPr/>
            </p:nvGraphicFramePr>
            <p:xfrm>
              <a:off x="9274314" y="4620272"/>
              <a:ext cx="2322000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3474" name="Prism 8" r:id="rId7" imgW="2905125" imgH="2828925" progId="Prism8.Document">
                      <p:embed/>
                    </p:oleObj>
                  </mc:Choice>
                  <mc:Fallback>
                    <p:oleObj name="Prism 8" r:id="rId7" imgW="2905125" imgH="2828925" progId="Prism8.Document">
                      <p:embed/>
                      <p:pic>
                        <p:nvPicPr>
                          <p:cNvPr id="0" name="개체 239"/>
                          <p:cNvPicPr preferRelativeResize="0"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9274314" y="4620272"/>
                            <a:ext cx="2322000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3" name="TextBox 52"/>
              <p:cNvSpPr txBox="1"/>
              <p:nvPr/>
            </p:nvSpPr>
            <p:spPr>
              <a:xfrm rot="16200000">
                <a:off x="8182430" y="5282295"/>
                <a:ext cx="184011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NIP 3L protein relative </a:t>
                </a:r>
              </a:p>
              <a:p>
                <a:pPr algn="ct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o TOMM20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직사각형 53"/>
              <p:cNvSpPr/>
              <p:nvPr/>
            </p:nvSpPr>
            <p:spPr>
              <a:xfrm>
                <a:off x="9484409" y="4764260"/>
                <a:ext cx="264919" cy="15923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9415567" y="508183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9543808" y="6202137"/>
                <a:ext cx="2696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9415567" y="5857032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9415567" y="543916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9415567" y="474716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직사각형 59"/>
              <p:cNvSpPr/>
              <p:nvPr/>
            </p:nvSpPr>
            <p:spPr>
              <a:xfrm>
                <a:off x="10640487" y="4701915"/>
                <a:ext cx="179462" cy="1356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0546407" y="4593255"/>
                <a:ext cx="2973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직사각형 61"/>
              <p:cNvSpPr/>
              <p:nvPr/>
            </p:nvSpPr>
            <p:spPr>
              <a:xfrm>
                <a:off x="10062675" y="4685150"/>
                <a:ext cx="262906" cy="1523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0006286" y="4593255"/>
                <a:ext cx="319509" cy="3139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ko-KR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9604988" y="4312894"/>
                <a:ext cx="13376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NIP3L protein </a:t>
                </a:r>
              </a:p>
            </p:txBody>
          </p:sp>
        </p:grpSp>
        <p:graphicFrame>
          <p:nvGraphicFramePr>
            <p:cNvPr id="66" name="개체 65"/>
            <p:cNvGraphicFramePr>
              <a:graphicFrameLocks noChangeAspect="1"/>
            </p:cNvGraphicFramePr>
            <p:nvPr/>
          </p:nvGraphicFramePr>
          <p:xfrm>
            <a:off x="1494997" y="4193999"/>
            <a:ext cx="2311400" cy="2160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3475" name="Prism 8" r:id="rId9" imgW="2905125" imgH="2714625" progId="Prism8.Document">
                    <p:embed/>
                  </p:oleObj>
                </mc:Choice>
                <mc:Fallback>
                  <p:oleObj name="Prism 8" r:id="rId9" imgW="2905125" imgH="2714625" progId="Prism8.Document">
                    <p:embed/>
                    <p:pic>
                      <p:nvPicPr>
                        <p:cNvPr id="0" name="개체 214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494997" y="4193999"/>
                          <a:ext cx="2311400" cy="2160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7" name="TextBox 66"/>
            <p:cNvSpPr txBox="1"/>
            <p:nvPr/>
          </p:nvSpPr>
          <p:spPr>
            <a:xfrm rot="16200000">
              <a:off x="509265" y="4755701"/>
              <a:ext cx="16450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FIS 1 protein relative 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to TOMM20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직사각형 67"/>
            <p:cNvSpPr/>
            <p:nvPr/>
          </p:nvSpPr>
          <p:spPr>
            <a:xfrm>
              <a:off x="1629373" y="4319191"/>
              <a:ext cx="304800" cy="17148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536307" y="48819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664548" y="5745868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536307" y="544349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536307" y="516235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536307" y="456436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536307" y="425990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직사각형 74"/>
            <p:cNvSpPr/>
            <p:nvPr/>
          </p:nvSpPr>
          <p:spPr>
            <a:xfrm>
              <a:off x="2222371" y="4276992"/>
              <a:ext cx="268147" cy="1384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6" name="직사각형 75"/>
            <p:cNvSpPr/>
            <p:nvPr/>
          </p:nvSpPr>
          <p:spPr>
            <a:xfrm>
              <a:off x="2734722" y="4249941"/>
              <a:ext cx="410595" cy="1655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7" name="TextBox 76"/>
            <p:cNvSpPr txBox="1"/>
            <p:nvPr/>
          </p:nvSpPr>
          <p:spPr>
            <a:xfrm flipH="1">
              <a:off x="2241548" y="4162389"/>
              <a:ext cx="170659" cy="2872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719582" y="4162389"/>
              <a:ext cx="368730" cy="2223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113474" y="3863748"/>
              <a:ext cx="11624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S 1 protein 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903694" y="3521715"/>
              <a:ext cx="408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868569" y="3507855"/>
              <a:ext cx="408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7052849" y="1537082"/>
              <a:ext cx="1568709" cy="1242050"/>
              <a:chOff x="7052849" y="1537082"/>
              <a:chExt cx="1568709" cy="1242050"/>
            </a:xfrm>
          </p:grpSpPr>
          <p:pic>
            <p:nvPicPr>
              <p:cNvPr id="4" name="그림 3"/>
              <p:cNvPicPr>
                <a:picLocks noChangeAspect="1"/>
              </p:cNvPicPr>
              <p:nvPr/>
            </p:nvPicPr>
            <p:blipFill rotWithShape="1">
              <a:blip r:embed="rId11"/>
              <a:srcRect l="24130" t="53136" r="14461" b="34372"/>
              <a:stretch>
                <a:fillRect/>
              </a:stretch>
            </p:blipFill>
            <p:spPr>
              <a:xfrm rot="5400000">
                <a:off x="6682200" y="1910441"/>
                <a:ext cx="1239340" cy="498041"/>
              </a:xfrm>
              <a:prstGeom prst="rect">
                <a:avLst/>
              </a:prstGeom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7564858" y="1537082"/>
                <a:ext cx="1056700" cy="12157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 </a:t>
                </a:r>
              </a:p>
              <a:p>
                <a:endPara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g</a:t>
                </a:r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I</a:t>
                </a:r>
              </a:p>
              <a:p>
                <a:endPara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 + MT</a:t>
                </a:r>
              </a:p>
              <a:p>
                <a:endPara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g</a:t>
                </a:r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I + MT 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" name="모서리가 둥근 직사각형 6"/>
          <p:cNvSpPr/>
          <p:nvPr/>
        </p:nvSpPr>
        <p:spPr>
          <a:xfrm>
            <a:off x="12533158" y="-250523"/>
            <a:ext cx="6018367" cy="688109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4310" y="102870"/>
            <a:ext cx="3178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454976" y="1163088"/>
            <a:ext cx="8418876" cy="4696882"/>
            <a:chOff x="1247614" y="652463"/>
            <a:chExt cx="8106497" cy="3998660"/>
          </a:xfrm>
        </p:grpSpPr>
        <p:pic>
          <p:nvPicPr>
            <p:cNvPr id="4" name="Picture 3" descr="C:\Users\Administrator\Desktop\血管细胞\新建文件夹\sham 2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8709" y="65246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C:\Users\Administrator\Desktop\血管细胞\新建文件夹\sham 3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5313" y="65246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C:\Users\Administrator\Desktop\血管细胞\新建文件夹\sham 4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7711" y="65246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6" descr="C:\Users\Administrator\Desktop\血管细胞\新建文件夹\sham 6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4111" y="65246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7" descr="C:\Users\Administrator\Desktop\血管细胞\新建文件夹\Ang II1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7711" y="1662378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8" descr="C:\Users\Administrator\Desktop\血管细胞\新建文件夹\Ang II2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8709" y="1662378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9" descr="C:\Users\Administrator\Desktop\血管细胞\新建文件夹\Ang II 4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5313" y="1657425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" descr="C:\Users\Administrator\Desktop\血管细胞\新建文件夹\Ang II 7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4111" y="1657425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1" descr="C:\Users\Administrator\Desktop\血管细胞\新建文件夹\SM 1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7517" y="266724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2" descr="C:\Users\Administrator\Desktop\血管细胞\新建文件夹\SM 2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8709" y="266724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3" descr="C:\Users\Administrator\Desktop\血管细胞\新建文件夹\SM 3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5120" y="266724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15" descr="C:\Users\Administrator\Desktop\血管细胞\新建文件夹\SM 10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4111" y="2667243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16" descr="C:\Users\Administrator\Desktop\血管细胞\新建文件夹\AM 1.tif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7517" y="3672205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17" descr="C:\Users\Administrator\Desktop\血管细胞\新建文件夹\AM 3.tif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7396" y="3672205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18" descr="C:\Users\Administrator\Desktop\血管细胞\新建文件夹\AM 4.tif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5313" y="3669408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19" descr="C:\Users\Administrator\Desktop\血管细胞\新建文件夹\AM 7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4111" y="3672205"/>
              <a:ext cx="1800000" cy="978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1247614" y="1084881"/>
              <a:ext cx="804599" cy="262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276029" y="1911457"/>
              <a:ext cx="804599" cy="262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gII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276029" y="3002813"/>
              <a:ext cx="804599" cy="4454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+mito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09603" y="3976623"/>
              <a:ext cx="743919" cy="4454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gII+mito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4310" y="102870"/>
            <a:ext cx="3178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UPPLEMENT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705" name="Picture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888"/>
          <a:stretch>
            <a:fillRect/>
          </a:stretch>
        </p:blipFill>
        <p:spPr bwMode="auto">
          <a:xfrm>
            <a:off x="414670" y="578882"/>
            <a:ext cx="5249863" cy="5608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270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390"/>
          <a:stretch>
            <a:fillRect/>
          </a:stretch>
        </p:blipFill>
        <p:spPr bwMode="auto">
          <a:xfrm>
            <a:off x="6319801" y="578882"/>
            <a:ext cx="5254625" cy="3557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直接连接符 6"/>
          <p:cNvCxnSpPr/>
          <p:nvPr/>
        </p:nvCxnSpPr>
        <p:spPr>
          <a:xfrm flipV="1">
            <a:off x="414670" y="6220043"/>
            <a:ext cx="524986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V="1">
            <a:off x="6319801" y="3788731"/>
            <a:ext cx="524986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V="1">
            <a:off x="6323339" y="4111259"/>
            <a:ext cx="524986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/>
          <p:cNvSpPr/>
          <p:nvPr/>
        </p:nvSpPr>
        <p:spPr>
          <a:xfrm>
            <a:off x="6280309" y="4264507"/>
            <a:ext cx="6096000" cy="55399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3.75+107.1667+114.9792+110.3958+109.5417+107.125)/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=108.826</a:t>
            </a:r>
          </a:p>
          <a:p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.28274+7.636233+8.78221+9.155256+12.29765+10.2472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6=10.73355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6096000" y="5403295"/>
            <a:ext cx="6096000" cy="707886"/>
          </a:xfrm>
          <a:prstGeom prst="rect">
            <a:avLst/>
          </a:prstGeom>
        </p:spPr>
        <p:txBody>
          <a:bodyPr>
            <a:spAutoFit/>
          </a:bodyPr>
          <a:lstStyle/>
          <a:p>
            <a:pPr hangingPunct="0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ere, we listed the evidence of blood pressure measurements in Sham group (systolic blood pressure (SBP) of 108.8±3.14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Hg,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which is consistent with the literature range for mid-pregnancy Sprague-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awley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rats (100-110 mmHg, Hypertension. 2021;78:1029–1037)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그물</Template>
  <TotalTime>7</TotalTime>
  <Words>816</Words>
  <Application>Microsoft Office PowerPoint</Application>
  <PresentationFormat>Widescreen</PresentationFormat>
  <Paragraphs>46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Malgun Gothic</vt:lpstr>
      <vt:lpstr>Malgun Gothic</vt:lpstr>
      <vt:lpstr>宋体</vt:lpstr>
      <vt:lpstr>Arial</vt:lpstr>
      <vt:lpstr>等线</vt:lpstr>
      <vt:lpstr>Office 테마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ungcheol Kang</dc:creator>
  <cp:lastModifiedBy>Dhivya Kathirvel</cp:lastModifiedBy>
  <cp:revision>805</cp:revision>
  <dcterms:created xsi:type="dcterms:W3CDTF">2023-09-19T12:04:00Z</dcterms:created>
  <dcterms:modified xsi:type="dcterms:W3CDTF">2026-02-03T06:46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F592E94694141C5BCE017FCDFB4B154_13</vt:lpwstr>
  </property>
  <property fmtid="{D5CDD505-2E9C-101B-9397-08002B2CF9AE}" pid="3" name="KSOProductBuildVer">
    <vt:lpwstr>2052-12.1.0.24034</vt:lpwstr>
  </property>
</Properties>
</file>